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12192000" cy="1440021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672" autoAdjust="0"/>
    <p:restoredTop sz="94660"/>
  </p:normalViewPr>
  <p:slideViewPr>
    <p:cSldViewPr snapToGrid="0">
      <p:cViewPr>
        <p:scale>
          <a:sx n="66" d="100"/>
          <a:sy n="66" d="100"/>
        </p:scale>
        <p:origin x="284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356703"/>
            <a:ext cx="10363200" cy="501340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563446"/>
            <a:ext cx="9144000" cy="3476717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4367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5474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66678"/>
            <a:ext cx="2628900" cy="1220351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66678"/>
            <a:ext cx="7734300" cy="1220351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1781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4820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590057"/>
            <a:ext cx="10515600" cy="599008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636813"/>
            <a:ext cx="10515600" cy="315004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1578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833390"/>
            <a:ext cx="5181600" cy="913680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833390"/>
            <a:ext cx="5181600" cy="913680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5575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66681"/>
            <a:ext cx="10515600" cy="278337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530053"/>
            <a:ext cx="5157787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260078"/>
            <a:ext cx="5157787" cy="773678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530053"/>
            <a:ext cx="5183188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260078"/>
            <a:ext cx="5183188" cy="773678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0977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5411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785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073367"/>
            <a:ext cx="6172200" cy="10233485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191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073367"/>
            <a:ext cx="6172200" cy="10233485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8038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66681"/>
            <a:ext cx="105156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833390"/>
            <a:ext cx="105156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BC8339-DA22-42DB-AF29-A2711A3E6295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3346867"/>
            <a:ext cx="41148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789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Box 61"/>
          <p:cNvSpPr txBox="1"/>
          <p:nvPr/>
        </p:nvSpPr>
        <p:spPr>
          <a:xfrm>
            <a:off x="33309" y="-748"/>
            <a:ext cx="332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6120228" y="2235043"/>
            <a:ext cx="332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4968" y="365258"/>
            <a:ext cx="4528774" cy="3232969"/>
          </a:xfrm>
          <a:prstGeom prst="rect">
            <a:avLst/>
          </a:prstGeom>
          <a:ln>
            <a:noFill/>
          </a:ln>
        </p:spPr>
      </p:pic>
      <p:sp>
        <p:nvSpPr>
          <p:cNvPr id="75" name="TextBox 74"/>
          <p:cNvSpPr txBox="1"/>
          <p:nvPr/>
        </p:nvSpPr>
        <p:spPr>
          <a:xfrm rot="16200000">
            <a:off x="-652705" y="1534146"/>
            <a:ext cx="20649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ell growth (%T</a:t>
            </a:r>
            <a:r>
              <a:rPr lang="en-GB" sz="1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433110" y="809989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,000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33110" y="1954806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515150" y="3322270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2475270" y="3322270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451250" y="3322270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4406441" y="3321902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2750904" y="3672165"/>
            <a:ext cx="11169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562183" y="4404490"/>
            <a:ext cx="5184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9036" y="4868997"/>
            <a:ext cx="3845832" cy="3273361"/>
          </a:xfrm>
          <a:prstGeom prst="rect">
            <a:avLst/>
          </a:prstGeom>
        </p:spPr>
      </p:pic>
      <p:sp>
        <p:nvSpPr>
          <p:cNvPr id="85" name="TextBox 84"/>
          <p:cNvSpPr txBox="1"/>
          <p:nvPr/>
        </p:nvSpPr>
        <p:spPr>
          <a:xfrm rot="16200000">
            <a:off x="-328459" y="6040719"/>
            <a:ext cx="23526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Luminescence signal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1041661" y="7047783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x10</a:t>
            </a:r>
            <a:r>
              <a:rPr lang="en-GB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1043693" y="6489254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x10</a:t>
            </a:r>
            <a:r>
              <a:rPr lang="en-GB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891189" y="5932994"/>
            <a:ext cx="9545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.5x10</a:t>
            </a:r>
            <a:r>
              <a:rPr lang="en-GB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041661" y="5361494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x10</a:t>
            </a:r>
            <a:r>
              <a:rPr lang="en-GB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891189" y="4797774"/>
            <a:ext cx="9545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.5x10</a:t>
            </a:r>
            <a:r>
              <a:rPr lang="en-GB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1947575" y="7828475"/>
            <a:ext cx="11169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2854381" y="7828475"/>
            <a:ext cx="13962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.luc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3922873" y="7828475"/>
            <a:ext cx="16324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hMAPK7.luc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210493" y="8542496"/>
            <a:ext cx="332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47351" y="2356635"/>
            <a:ext cx="4528774" cy="3339752"/>
          </a:xfrm>
          <a:prstGeom prst="rect">
            <a:avLst/>
          </a:prstGeom>
          <a:ln>
            <a:noFill/>
          </a:ln>
        </p:spPr>
      </p:pic>
      <p:sp>
        <p:nvSpPr>
          <p:cNvPr id="96" name="TextBox 95"/>
          <p:cNvSpPr txBox="1"/>
          <p:nvPr/>
        </p:nvSpPr>
        <p:spPr>
          <a:xfrm rot="16200000">
            <a:off x="5749363" y="3851920"/>
            <a:ext cx="20649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ell growth (%T</a:t>
            </a:r>
            <a:r>
              <a:rPr lang="en-GB" sz="1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6839473" y="2365565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,000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6835930" y="3843757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7921513" y="5549356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8881633" y="5549356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9857613" y="5549356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10812804" y="5548988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9157267" y="5899251"/>
            <a:ext cx="11169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4" name="Picture 103"/>
          <p:cNvPicPr>
            <a:picLocks noChangeAspect="1"/>
          </p:cNvPicPr>
          <p:nvPr/>
        </p:nvPicPr>
        <p:blipFill rotWithShape="1">
          <a:blip r:embed="rId5"/>
          <a:srcRect l="70416" t="7945" r="21986" b="72172"/>
          <a:stretch/>
        </p:blipFill>
        <p:spPr>
          <a:xfrm>
            <a:off x="8017391" y="2536198"/>
            <a:ext cx="608343" cy="944532"/>
          </a:xfrm>
          <a:prstGeom prst="rect">
            <a:avLst/>
          </a:prstGeom>
        </p:spPr>
      </p:pic>
      <p:sp>
        <p:nvSpPr>
          <p:cNvPr id="105" name="TextBox 104"/>
          <p:cNvSpPr txBox="1"/>
          <p:nvPr/>
        </p:nvSpPr>
        <p:spPr>
          <a:xfrm>
            <a:off x="8517694" y="2704119"/>
            <a:ext cx="24545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– luciferase 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8517694" y="3042078"/>
            <a:ext cx="24545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hMAPK7 – luciferase 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6"/>
          <a:srcRect t="19199"/>
          <a:stretch/>
        </p:blipFill>
        <p:spPr>
          <a:xfrm>
            <a:off x="210493" y="8542496"/>
            <a:ext cx="11534317" cy="6019131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7"/>
          <a:srcRect l="65039" r="27774" b="73985"/>
          <a:stretch/>
        </p:blipFill>
        <p:spPr>
          <a:xfrm>
            <a:off x="9466489" y="8538779"/>
            <a:ext cx="530502" cy="1240082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9894777" y="8625531"/>
            <a:ext cx="11169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9894777" y="8887639"/>
            <a:ext cx="15248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hMAPK7 1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9894777" y="9163973"/>
            <a:ext cx="15248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hMAPK7 2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9894777" y="9420737"/>
            <a:ext cx="15248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hMAPK7 3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8"/>
          <a:srcRect l="69526" t="27339" r="24731" b="56340"/>
          <a:stretch/>
        </p:blipFill>
        <p:spPr>
          <a:xfrm>
            <a:off x="1729130" y="669827"/>
            <a:ext cx="444821" cy="704300"/>
          </a:xfrm>
          <a:prstGeom prst="rect">
            <a:avLst/>
          </a:prstGeom>
        </p:spPr>
      </p:pic>
      <p:sp>
        <p:nvSpPr>
          <p:cNvPr id="50" name="TextBox 49"/>
          <p:cNvSpPr txBox="1"/>
          <p:nvPr/>
        </p:nvSpPr>
        <p:spPr>
          <a:xfrm>
            <a:off x="2112004" y="758875"/>
            <a:ext cx="8857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112004" y="1028265"/>
            <a:ext cx="21386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- luciferase 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23355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1</TotalTime>
  <Words>61</Words>
  <Application>Microsoft Office PowerPoint</Application>
  <PresentationFormat>Custom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East Angl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ll Green (MED)</dc:creator>
  <cp:lastModifiedBy>Darrell Green (MED - Staff)</cp:lastModifiedBy>
  <cp:revision>90</cp:revision>
  <dcterms:created xsi:type="dcterms:W3CDTF">2017-04-04T08:45:42Z</dcterms:created>
  <dcterms:modified xsi:type="dcterms:W3CDTF">2020-05-14T11:25:58Z</dcterms:modified>
</cp:coreProperties>
</file>